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343" r:id="rId2"/>
    <p:sldId id="257" r:id="rId3"/>
    <p:sldId id="272" r:id="rId4"/>
    <p:sldId id="264" r:id="rId5"/>
    <p:sldId id="340" r:id="rId6"/>
    <p:sldId id="333" r:id="rId7"/>
    <p:sldId id="342" r:id="rId8"/>
    <p:sldId id="314" r:id="rId9"/>
    <p:sldId id="339" r:id="rId10"/>
  </p:sldIdLst>
  <p:sldSz cx="6858000" cy="9906000" type="A4"/>
  <p:notesSz cx="6797675" cy="9874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616" autoAdjust="0"/>
  </p:normalViewPr>
  <p:slideViewPr>
    <p:cSldViewPr>
      <p:cViewPr varScale="1">
        <p:scale>
          <a:sx n="74" d="100"/>
          <a:sy n="74" d="100"/>
        </p:scale>
        <p:origin x="310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4029"/>
          </a:xfrm>
          <a:prstGeom prst="rect">
            <a:avLst/>
          </a:prstGeom>
        </p:spPr>
        <p:txBody>
          <a:bodyPr vert="horz" lIns="91102" tIns="45551" rIns="91102" bIns="45551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4029"/>
          </a:xfrm>
          <a:prstGeom prst="rect">
            <a:avLst/>
          </a:prstGeom>
        </p:spPr>
        <p:txBody>
          <a:bodyPr vert="horz" lIns="91102" tIns="45551" rIns="91102" bIns="45551" rtlCol="0"/>
          <a:lstStyle>
            <a:lvl1pPr algn="r">
              <a:defRPr sz="1200"/>
            </a:lvl1pPr>
          </a:lstStyle>
          <a:p>
            <a:fld id="{EE4BD6C6-9A42-48C7-9A88-B7BCB5F66D7C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16138" y="739775"/>
            <a:ext cx="2565400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02" tIns="45551" rIns="91102" bIns="4555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5" y="4690908"/>
            <a:ext cx="5438775" cy="4443097"/>
          </a:xfrm>
          <a:prstGeom prst="rect">
            <a:avLst/>
          </a:prstGeom>
        </p:spPr>
        <p:txBody>
          <a:bodyPr vert="horz" lIns="91102" tIns="45551" rIns="91102" bIns="45551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643"/>
            <a:ext cx="2946400" cy="494029"/>
          </a:xfrm>
          <a:prstGeom prst="rect">
            <a:avLst/>
          </a:prstGeom>
        </p:spPr>
        <p:txBody>
          <a:bodyPr vert="horz" lIns="91102" tIns="45551" rIns="91102" bIns="45551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378643"/>
            <a:ext cx="2946400" cy="494029"/>
          </a:xfrm>
          <a:prstGeom prst="rect">
            <a:avLst/>
          </a:prstGeom>
        </p:spPr>
        <p:txBody>
          <a:bodyPr vert="horz" lIns="91102" tIns="45551" rIns="91102" bIns="45551" rtlCol="0" anchor="b"/>
          <a:lstStyle>
            <a:lvl1pPr algn="r">
              <a:defRPr sz="1200"/>
            </a:lvl1pPr>
          </a:lstStyle>
          <a:p>
            <a:fld id="{3C8B43EF-309C-4A29-8654-0151A861B2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9697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16138" y="739775"/>
            <a:ext cx="2565400" cy="3703638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8B43EF-309C-4A29-8654-0151A861B21C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27050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16138" y="739775"/>
            <a:ext cx="2565400" cy="3703638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8B43EF-309C-4A29-8654-0151A861B21C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3129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16138" y="739775"/>
            <a:ext cx="2565400" cy="3703638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8B43EF-309C-4A29-8654-0151A861B21C}" type="slidenum">
              <a:rPr lang="ko-KR" altLang="en-US" smtClean="0"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9138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106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438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4021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797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7431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7967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9190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0071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3366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918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1292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C385B-356E-4413-8F2E-005D9A205F54}" type="datetimeFigureOut">
              <a:rPr lang="ko-KR" altLang="en-US" smtClean="0"/>
              <a:t>2020-05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9725F-AF7B-45B1-B2AA-4F1009580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33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3973F0FB-8158-4F66-9046-D95E34BC71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738743"/>
              </p:ext>
            </p:extLst>
          </p:nvPr>
        </p:nvGraphicFramePr>
        <p:xfrm>
          <a:off x="411890" y="2068685"/>
          <a:ext cx="6105524" cy="491121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66762">
                  <a:extLst>
                    <a:ext uri="{9D8B030D-6E8A-4147-A177-3AD203B41FA5}">
                      <a16:colId xmlns:a16="http://schemas.microsoft.com/office/drawing/2014/main" val="333337161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300647628"/>
                    </a:ext>
                  </a:extLst>
                </a:gridCol>
                <a:gridCol w="162560">
                  <a:extLst>
                    <a:ext uri="{9D8B030D-6E8A-4147-A177-3AD203B41FA5}">
                      <a16:colId xmlns:a16="http://schemas.microsoft.com/office/drawing/2014/main" val="3675165309"/>
                    </a:ext>
                  </a:extLst>
                </a:gridCol>
                <a:gridCol w="447040">
                  <a:extLst>
                    <a:ext uri="{9D8B030D-6E8A-4147-A177-3AD203B41FA5}">
                      <a16:colId xmlns:a16="http://schemas.microsoft.com/office/drawing/2014/main" val="495745663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3556983544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4183035890"/>
                    </a:ext>
                  </a:extLst>
                </a:gridCol>
                <a:gridCol w="162560">
                  <a:extLst>
                    <a:ext uri="{9D8B030D-6E8A-4147-A177-3AD203B41FA5}">
                      <a16:colId xmlns:a16="http://schemas.microsoft.com/office/drawing/2014/main" val="3510482115"/>
                    </a:ext>
                  </a:extLst>
                </a:gridCol>
                <a:gridCol w="751840">
                  <a:extLst>
                    <a:ext uri="{9D8B030D-6E8A-4147-A177-3AD203B41FA5}">
                      <a16:colId xmlns:a16="http://schemas.microsoft.com/office/drawing/2014/main" val="112800328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274649872"/>
                    </a:ext>
                  </a:extLst>
                </a:gridCol>
                <a:gridCol w="690562">
                  <a:extLst>
                    <a:ext uri="{9D8B030D-6E8A-4147-A177-3AD203B41FA5}">
                      <a16:colId xmlns:a16="http://schemas.microsoft.com/office/drawing/2014/main" val="2837216776"/>
                    </a:ext>
                  </a:extLst>
                </a:gridCol>
              </a:tblGrid>
              <a:tr h="532444"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HC </a:t>
                      </a:r>
                    </a:p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estriction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eptide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88265"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tart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Length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equence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</a:endParaRPr>
                    </a:p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esidue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BIMAS </a:t>
                      </a:r>
                    </a:p>
                    <a:p>
                      <a:pPr 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core</a:t>
                      </a:r>
                      <a:r>
                        <a:rPr lang="en-US" sz="900" i="1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¶</a:t>
                      </a:r>
                      <a:endParaRPr lang="ko-KR" sz="1000" i="1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YRPEITHI Score</a:t>
                      </a:r>
                      <a:r>
                        <a:rPr lang="en-US" sz="900" i="1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¶</a:t>
                      </a:r>
                      <a:endParaRPr lang="ko-KR" sz="1000" i="1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IEDB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</a:endParaRPr>
                    </a:p>
                    <a:p>
                      <a:pPr algn="ctr" fontAlgn="ctr" latinLnBrk="1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ank</a:t>
                      </a:r>
                      <a:r>
                        <a:rPr lang="en-US" sz="900" i="1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§</a:t>
                      </a:r>
                      <a:endParaRPr lang="ko-KR" sz="1000" i="1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7556530"/>
                  </a:ext>
                </a:extLst>
              </a:tr>
              <a:tr h="312769">
                <a:tc rowSpan="7"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H-2K</a:t>
                      </a:r>
                      <a:r>
                        <a:rPr lang="en-US" sz="900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b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1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1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0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EDSDFVFVV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.5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12075091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2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2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DSDFVFVVL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.0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9.5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66330952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3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3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DFVFVV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2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1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2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68464680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37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37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IGCIMYTL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6.4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49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29986873"/>
                  </a:ext>
                </a:extLst>
              </a:tr>
              <a:tr h="208513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44854949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Trp2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80</a:t>
                      </a:r>
                      <a:r>
                        <a:rPr lang="en-US" sz="900" i="1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†</a:t>
                      </a:r>
                      <a:endParaRPr lang="ko-KR" sz="1000" i="1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80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VYDFFVW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6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07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13463189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Ova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5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55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KVVRFDK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327444"/>
                  </a:ext>
                </a:extLst>
              </a:tr>
              <a:tr h="312769">
                <a:tc rowSpan="8"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H-2D</a:t>
                      </a:r>
                      <a:r>
                        <a:rPr lang="en-US" sz="900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b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62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62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IKKNEYSI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2.0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.1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15400299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97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97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HELLNDEFF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3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.4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67604403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32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32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LDPSSRKPL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036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4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.0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77828289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45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45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KGVENPLPD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6.8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7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.9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34267534"/>
                  </a:ext>
                </a:extLst>
              </a:tr>
              <a:tr h="31276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LK1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45/9M</a:t>
                      </a:r>
                      <a:r>
                        <a:rPr lang="en-US" sz="900" i="1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‡</a:t>
                      </a:r>
                      <a:endParaRPr lang="ko-KR" sz="1000" i="1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45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KGVENPLP</a:t>
                      </a:r>
                      <a:r>
                        <a:rPr lang="en-US" sz="900" u="sng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6.6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27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2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48420445"/>
                  </a:ext>
                </a:extLst>
              </a:tr>
              <a:tr h="208513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29647854"/>
                  </a:ext>
                </a:extLst>
              </a:tr>
              <a:tr h="26064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hgp100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5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KVPRNQDW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89</a:t>
                      </a:r>
                      <a:endParaRPr lang="ko-KR" sz="1000" kern="10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6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33811265"/>
                  </a:ext>
                </a:extLst>
              </a:tr>
              <a:tr h="26064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20320" algn="l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ur</a:t>
                      </a:r>
                      <a:r>
                        <a:rPr lang="en-US" sz="900" kern="1200" baseline="-25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0</a:t>
                      </a:r>
                      <a:r>
                        <a:rPr lang="en-US" sz="900" kern="1200" baseline="300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 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0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53035" algn="just" fontAlgn="ctr" latinLnBrk="1">
                        <a:lnSpc>
                          <a:spcPts val="159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TFKNWPFL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 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716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4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3</a:t>
                      </a:r>
                      <a:endParaRPr lang="ko-KR" sz="1000" kern="100" dirty="0">
                        <a:effectLst/>
                        <a:latin typeface="Cambria" panose="020405030504060302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2623264"/>
                  </a:ext>
                </a:extLst>
              </a:tr>
            </a:tbl>
          </a:graphicData>
        </a:graphic>
      </p:graphicFrame>
      <p:sp>
        <p:nvSpPr>
          <p:cNvPr id="5" name="직사각형 4">
            <a:extLst>
              <a:ext uri="{FF2B5EF4-FFF2-40B4-BE49-F238E27FC236}">
                <a16:creationId xmlns:a16="http://schemas.microsoft.com/office/drawing/2014/main" id="{B97F1E36-C62B-4F25-AF83-323AE15706E8}"/>
              </a:ext>
            </a:extLst>
          </p:cNvPr>
          <p:cNvSpPr/>
          <p:nvPr/>
        </p:nvSpPr>
        <p:spPr>
          <a:xfrm>
            <a:off x="421549" y="1420033"/>
            <a:ext cx="6086206" cy="498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200"/>
              </a:spcAft>
            </a:pPr>
            <a:r>
              <a:rPr lang="en-US" altLang="ko-KR" sz="1200" i="1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Table S1</a:t>
            </a:r>
            <a:r>
              <a:rPr lang="en-US" altLang="ko-KR" sz="12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 The putative affinity of mouse PLK1-derived peptides for mouse MHC class I molecules.</a:t>
            </a:r>
            <a:endParaRPr lang="ko-KR" altLang="ko-KR" sz="12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00231311-F7BD-4BDA-A243-9F97C43A337A}"/>
              </a:ext>
            </a:extLst>
          </p:cNvPr>
          <p:cNvSpPr/>
          <p:nvPr/>
        </p:nvSpPr>
        <p:spPr>
          <a:xfrm>
            <a:off x="403304" y="7102734"/>
            <a:ext cx="6014902" cy="13160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n-US" altLang="ko-KR" sz="10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he binding scores were assessed using BIMAS (https://www-bimas.cit.nih.gov/molbio/hla_bind/), </a:t>
            </a:r>
            <a:r>
              <a:rPr lang="en-US" altLang="ko-KR" sz="1000" dirty="0">
                <a:solidFill>
                  <a:srgbClr val="000000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YRPEITHI</a:t>
            </a:r>
            <a:r>
              <a:rPr lang="en-US" altLang="ko-KR" sz="10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(http://www.syfpeithi.de/0-Home.htm), and IEDB (http://www.iedb.org/) software.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kern="100" dirty="0" err="1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rp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; tyrosinase-related protein, Ova; Ovalbumin, </a:t>
            </a:r>
            <a:r>
              <a:rPr lang="en-US" altLang="ko-KR" sz="1000" kern="100" dirty="0" err="1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hgp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; human glycoprotein.</a:t>
            </a:r>
            <a:endParaRPr lang="ko-KR" altLang="ko-KR" sz="10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altLang="ko-KR" sz="1000" b="1" i="1" dirty="0">
                <a:solidFill>
                  <a:srgbClr val="000000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¶</a:t>
            </a:r>
            <a:r>
              <a:rPr lang="en-US" altLang="ko-KR" sz="10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; 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High Score = good binder. </a:t>
            </a:r>
            <a:endParaRPr lang="ko-KR" altLang="ko-KR" sz="10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altLang="ko-KR" sz="1000" b="1" i="1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§</a:t>
            </a:r>
            <a:r>
              <a:rPr lang="en-US" altLang="ko-KR" sz="10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; 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Low Score = good binder. </a:t>
            </a:r>
            <a:endParaRPr lang="ko-KR" altLang="ko-KR" sz="10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altLang="ko-KR" sz="1000" b="1" i="1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†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;The well-known peptides were incorporated for comparison. </a:t>
            </a:r>
            <a:endParaRPr lang="ko-KR" altLang="ko-KR" sz="10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altLang="ko-KR" sz="1000" i="1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‡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; The </a:t>
            </a:r>
            <a:r>
              <a:rPr lang="en-US" altLang="ko-KR" sz="1000" kern="100" dirty="0" err="1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heteroclitic</a:t>
            </a:r>
            <a:r>
              <a:rPr lang="en-US" altLang="ko-KR" sz="1000" kern="100" dirty="0">
                <a:solidFill>
                  <a:srgbClr val="222222"/>
                </a:solidFill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epitope peptides have a substitution at position 9 (with M) to improve the MHC-I binding. </a:t>
            </a:r>
            <a:endParaRPr lang="ko-KR" altLang="ko-KR" sz="1000" kern="100" dirty="0">
              <a:latin typeface="Cambria" panose="020405030504060302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4087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ABDD087A-4A48-4DBF-BDBA-11B77521FB5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418" y="4338771"/>
            <a:ext cx="2432639" cy="88147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8797" y="1548561"/>
            <a:ext cx="1844109" cy="2128113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2466" y="1600200"/>
            <a:ext cx="2334492" cy="26356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90600" y="154856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06595" y="42941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539586" y="5689223"/>
            <a:ext cx="5774743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i="1" dirty="0">
                <a:latin typeface="Cambria" panose="02040503050406030204" pitchFamily="18" charset="0"/>
              </a:rPr>
              <a:t>Supplementary Figure </a:t>
            </a:r>
            <a:r>
              <a:rPr lang="en-US" altLang="ko-KR" sz="1050" b="1" i="1" dirty="0">
                <a:latin typeface="Cambria" panose="02040503050406030204" pitchFamily="18" charset="0"/>
                <a:ea typeface="Cambria" panose="02040503050406030204" pitchFamily="18" charset="0"/>
              </a:rPr>
              <a:t>S1</a:t>
            </a:r>
            <a:r>
              <a:rPr lang="en-US" altLang="ko-KR" sz="1050" b="1" dirty="0">
                <a:latin typeface="Cambria" pitchFamily="18" charset="0"/>
                <a:ea typeface="Cambria" panose="02040503050406030204" pitchFamily="18" charset="0"/>
              </a:rPr>
              <a:t>. Binding</a:t>
            </a:r>
            <a:r>
              <a:rPr lang="ko-KR" altLang="en-US" sz="1050" b="1" dirty="0">
                <a:latin typeface="Cambria" pitchFamily="18" charset="0"/>
              </a:rPr>
              <a:t> </a:t>
            </a:r>
            <a:r>
              <a:rPr lang="en-US" altLang="ko-KR" sz="1050" b="1" dirty="0">
                <a:latin typeface="Cambria" pitchFamily="18" charset="0"/>
                <a:ea typeface="Cambria" panose="02040503050406030204" pitchFamily="18" charset="0"/>
              </a:rPr>
              <a:t>analysis of PLK1-derived peptides and expression of PLK1 in murine tumor cell lines. A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Serially diluted peptides PLK1</a:t>
            </a:r>
            <a:r>
              <a:rPr lang="en-US" altLang="ko-KR" sz="1050" baseline="-25000" dirty="0">
                <a:latin typeface="Cambria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 (DSDFVFVVL) and PLK1</a:t>
            </a:r>
            <a:r>
              <a:rPr lang="en-US" altLang="ko-KR" sz="1050" baseline="-25000" dirty="0">
                <a:latin typeface="Cambria" pitchFamily="18" charset="0"/>
                <a:ea typeface="Cambria" panose="02040503050406030204" pitchFamily="18" charset="0"/>
              </a:rPr>
              <a:t>345/9M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(KGVENPLPM) as the indicated concentrations were incubated with RMA-S cells overnight, and surface stabilization of H-2D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nd H-2K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MHC-I molecules on the cells was determined by flow 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cytometry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B.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Peptide-MHC dissociation assays. After incubating RMA-S cells with peptides for 1 h at 20 µg/ml, the cells were washed and expression of MHC-I was measured at various time points. Results are the sum of two independent experiments, and presented as the percentage of the MFI remaining as compared to 0 h (100%).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Points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mean for two separate experiments;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bars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SD. Peptides Trp2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80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(SVYDFFVWL) and hgp100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25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(KVPRNQDWL) were included for comparison as positive H-2K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nd H-2D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binders, respectively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C.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To verify the expression of PLK1 protein in tumors, western blotting was performed with whole cell extracts from mouse tumor cell lines </a:t>
            </a:r>
            <a:r>
              <a:rPr lang="en-US" altLang="ko-KR" sz="1050" dirty="0">
                <a:latin typeface="Cambria" pitchFamily="18" charset="0"/>
              </a:rPr>
              <a:t>EL4 (lymphoma), C1498 (leukemia), B16 (melanoma), MC38 (colon carcinoma), and Hepa1-6 (hepatoma). M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ouse </a:t>
            </a:r>
            <a:r>
              <a:rPr lang="en-US" altLang="ko-KR" sz="1050" dirty="0" err="1">
                <a:latin typeface="Cambria" pitchFamily="18" charset="0"/>
                <a:ea typeface="Cambria" panose="02040503050406030204" pitchFamily="18" charset="0"/>
              </a:rPr>
              <a:t>splenocytes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 (SPL) and normal liver cell line FL83B were incorporated </a:t>
            </a:r>
            <a:r>
              <a:rPr lang="en-US" altLang="ko-KR" sz="1050" dirty="0">
                <a:latin typeface="Cambria" pitchFamily="18" charset="0"/>
              </a:rPr>
              <a:t>for comparison. These experiments were repeated twice with similar results.</a:t>
            </a:r>
            <a:endParaRPr lang="en-US" altLang="ko-KR" sz="105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1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50629" y="154856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686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3" t="3728" r="6559" b="4064"/>
          <a:stretch/>
        </p:blipFill>
        <p:spPr>
          <a:xfrm>
            <a:off x="342161" y="3755660"/>
            <a:ext cx="2629640" cy="1607003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5" r="3208"/>
          <a:stretch/>
        </p:blipFill>
        <p:spPr>
          <a:xfrm>
            <a:off x="342160" y="1217819"/>
            <a:ext cx="5982440" cy="215955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1324" y="118574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8600" y="356063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359094" y="6019800"/>
            <a:ext cx="5982440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i="1" dirty="0">
                <a:latin typeface="Cambria" panose="02040503050406030204" pitchFamily="18" charset="0"/>
              </a:rPr>
              <a:t>Supplementary Figure S2</a:t>
            </a:r>
            <a:r>
              <a:rPr lang="en-US" altLang="ko-KR" sz="1050" b="1" dirty="0">
                <a:latin typeface="Cambria" pitchFamily="18" charset="0"/>
              </a:rPr>
              <a:t>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PLK1</a:t>
            </a:r>
            <a:r>
              <a:rPr lang="en-US" altLang="ko-KR" sz="1050" b="1" baseline="-25000" dirty="0">
                <a:latin typeface="Cambria" pitchFamily="18" charset="0"/>
                <a:ea typeface="Cambria" pitchFamily="18" charset="0"/>
              </a:rPr>
              <a:t>122</a:t>
            </a:r>
            <a:r>
              <a:rPr lang="en-US" altLang="ko-KR" sz="1050" b="1" dirty="0">
                <a:latin typeface="Cambria" pitchFamily="18" charset="0"/>
              </a:rPr>
              <a:t>DC_TriVax immunization provokes long-lasting antitumor effects against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subcutaneously established C1498 leukemia</a:t>
            </a:r>
            <a:r>
              <a:rPr lang="en-US" altLang="ko-KR" sz="1050" b="1" dirty="0">
                <a:latin typeface="Cambria" pitchFamily="18" charset="0"/>
              </a:rPr>
              <a:t>. </a:t>
            </a:r>
            <a:r>
              <a:rPr lang="en-US" altLang="ko-KR" sz="1050" dirty="0">
                <a:latin typeface="Cambria" pitchFamily="18" charset="0"/>
              </a:rPr>
              <a:t>In a parallel with </a:t>
            </a:r>
            <a:r>
              <a:rPr lang="en-US" altLang="ko-KR" sz="1050" i="1" dirty="0">
                <a:latin typeface="Cambria" pitchFamily="18" charset="0"/>
              </a:rPr>
              <a:t>Figure 1D</a:t>
            </a:r>
            <a:r>
              <a:rPr lang="en-US" altLang="ko-KR" sz="1050" dirty="0">
                <a:latin typeface="Cambria" pitchFamily="18" charset="0"/>
              </a:rPr>
              <a:t>, B6 mice (4 per group) were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inoculated subcutaneously with 2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0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6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C1498-luc cells on day0, and received intravenously 2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0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6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PLK1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122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-</a:t>
            </a:r>
            <a:r>
              <a:rPr lang="en-US" altLang="ko-KR" sz="1050" dirty="0">
                <a:latin typeface="Cambria" pitchFamily="18" charset="0"/>
              </a:rPr>
              <a:t>loaded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DCs (prime) on day7. Seven-days later, the mice received a booster immunization with 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TriVax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composed of 100 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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g of PLK1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122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50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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g of poly-IC, and 100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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g of anti-CD40 Abs, followed by weekly bioluminescence imaging. Non-vaccinated mice (No Vax) and 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-loaded DCs prime-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TriVax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booster-vaccinated mice (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 were included as controls. 49-days later, tumor-free (rejected) mice received subcutaneous tumor 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rechallenge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with 2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0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6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C1498-luc cells in the opposite flank. Naive, unvaccinated mice inoculated with the same number of C1498-luc cells were incorporated </a:t>
            </a:r>
            <a:r>
              <a:rPr lang="en-US" altLang="ko-KR" sz="1050" dirty="0">
                <a:latin typeface="Cambria" pitchFamily="18" charset="0"/>
              </a:rPr>
              <a:t>for comparison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A.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Tumor growth was monitored by time course of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in vivo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bioluminescence imaging in individual mice (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left and middle panel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, and average radiance per mouse is shown (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right panel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. Images were adjusted to the same pseudo color scale to show relative bioluminescence changes over time.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Points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average values of photons in mouse; </a:t>
            </a:r>
            <a:r>
              <a:rPr lang="en-US" altLang="ko-KR" sz="1050" i="1" dirty="0">
                <a:latin typeface="Cambria" pitchFamily="18" charset="0"/>
              </a:rPr>
              <a:t>bars,</a:t>
            </a:r>
            <a:r>
              <a:rPr lang="en-US" altLang="ko-KR" sz="1050" dirty="0">
                <a:latin typeface="Cambria" pitchFamily="18" charset="0"/>
              </a:rPr>
              <a:t> SD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B</a:t>
            </a:r>
            <a:r>
              <a:rPr lang="en-US" altLang="ko-KR" sz="1050" b="1" i="1" dirty="0">
                <a:latin typeface="Cambria" pitchFamily="18" charset="0"/>
                <a:ea typeface="Cambria" pitchFamily="18" charset="0"/>
              </a:rPr>
              <a:t>.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Tumor sizes were determined in individual mice by measurements of two opposing diameters and are presented as tumor areas in mm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2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.</a:t>
            </a:r>
            <a:r>
              <a:rPr lang="en-US" altLang="ko-KR" sz="1050" i="1" dirty="0">
                <a:latin typeface="Cambria" panose="02040503050406030204" pitchFamily="18" charset="0"/>
              </a:rPr>
              <a:t> Vertical arrows, </a:t>
            </a:r>
            <a:r>
              <a:rPr lang="en-US" altLang="ko-KR" sz="1050" dirty="0">
                <a:latin typeface="Cambria" panose="02040503050406030204" pitchFamily="18" charset="0"/>
              </a:rPr>
              <a:t>times of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tumor 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rechallenge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;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points,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mean for each </a:t>
            </a:r>
            <a:r>
              <a:rPr lang="en-US" altLang="ko-KR" sz="1050" dirty="0">
                <a:latin typeface="Cambria" pitchFamily="18" charset="0"/>
              </a:rPr>
              <a:t>group of mice; </a:t>
            </a:r>
            <a:r>
              <a:rPr lang="en-US" altLang="ko-KR" sz="1050" i="1" dirty="0">
                <a:latin typeface="Cambria" pitchFamily="18" charset="0"/>
              </a:rPr>
              <a:t>bars,</a:t>
            </a:r>
            <a:r>
              <a:rPr lang="en-US" altLang="ko-KR" sz="1050" dirty="0">
                <a:latin typeface="Cambria" pitchFamily="18" charset="0"/>
              </a:rPr>
              <a:t> SD. These experiments were repeated twice with similar results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D5A136-7597-4310-8472-3CBA58726959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2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0251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2" t="4110" r="6204" b="7611"/>
          <a:stretch/>
        </p:blipFill>
        <p:spPr>
          <a:xfrm>
            <a:off x="408921" y="3469322"/>
            <a:ext cx="3692703" cy="1788478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8" t="3781" r="10912" b="3356"/>
          <a:stretch/>
        </p:blipFill>
        <p:spPr>
          <a:xfrm>
            <a:off x="4248990" y="3560264"/>
            <a:ext cx="1580966" cy="169123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15" y="1576818"/>
            <a:ext cx="3549092" cy="167420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00"/>
          <a:stretch/>
        </p:blipFill>
        <p:spPr>
          <a:xfrm>
            <a:off x="3752127" y="1742148"/>
            <a:ext cx="2877273" cy="144591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5843" y="154886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712910" y="159588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101622" y="33905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45843" y="33905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98289" y="6019800"/>
            <a:ext cx="6240463" cy="2192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i="1" dirty="0">
                <a:latin typeface="Cambria" pitchFamily="18" charset="0"/>
              </a:rPr>
              <a:t>Supplementary Figure S3</a:t>
            </a:r>
            <a:r>
              <a:rPr lang="en-US" altLang="ko-KR" sz="1050" b="1" dirty="0">
                <a:latin typeface="Cambria" pitchFamily="18" charset="0"/>
              </a:rPr>
              <a:t>. Therapeutic antitumor effects of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PLK1</a:t>
            </a:r>
            <a:r>
              <a:rPr lang="en-US" altLang="ko-KR" sz="1050" b="1" baseline="-25000" dirty="0">
                <a:latin typeface="Cambria" pitchFamily="18" charset="0"/>
                <a:ea typeface="Cambria" pitchFamily="18" charset="0"/>
              </a:rPr>
              <a:t>122</a:t>
            </a:r>
            <a:r>
              <a:rPr lang="en-US" altLang="ko-KR" sz="1050" b="1" dirty="0">
                <a:latin typeface="Cambria" pitchFamily="18" charset="0"/>
              </a:rPr>
              <a:t>DC_TriVax</a:t>
            </a:r>
            <a:r>
              <a:rPr lang="ko-KR" altLang="en-US" sz="1050" b="1" dirty="0">
                <a:latin typeface="Cambria" pitchFamily="18" charset="0"/>
              </a:rPr>
              <a:t> </a:t>
            </a:r>
            <a:r>
              <a:rPr lang="en-US" altLang="ko-KR" sz="1050" b="1" dirty="0">
                <a:latin typeface="Cambria" pitchFamily="18" charset="0"/>
              </a:rPr>
              <a:t>vaccination against established Hepa1-6 hepatocellular carcinoma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A. </a:t>
            </a:r>
            <a:r>
              <a:rPr lang="en-US" altLang="ko-KR" sz="1050" dirty="0">
                <a:latin typeface="Cambria" pitchFamily="18" charset="0"/>
              </a:rPr>
              <a:t>B6 mice (4 per group) were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inoculated subcutaneously with 2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0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6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Hepa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-6-luc cells on day0, and vaccinated as in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Figure S2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followed by weekly bioluminescence imaging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B.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Each line corresponds to the tumor size of each individual mouse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C.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48-days later, tumor-free (rejected) mice received subcutaneous tumor 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rechallenge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with 2 </a:t>
            </a:r>
            <a:r>
              <a:rPr lang="en-US" altLang="ko-KR" sz="1050" dirty="0">
                <a:latin typeface="Cambria" pitchFamily="18" charset="0"/>
                <a:ea typeface="Cambria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10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6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C1498-luc cells. Naive, unvaccinated mice inoculated with the same number of C1498-luc cells were incorporated </a:t>
            </a:r>
            <a:r>
              <a:rPr lang="en-US" altLang="ko-KR" sz="1050" dirty="0">
                <a:latin typeface="Cambria" pitchFamily="18" charset="0"/>
              </a:rPr>
              <a:t>for comparison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D</a:t>
            </a:r>
            <a:r>
              <a:rPr lang="en-US" altLang="ko-KR" sz="1050" b="1" i="1" dirty="0">
                <a:latin typeface="Cambria" pitchFamily="18" charset="0"/>
                <a:ea typeface="Cambria" pitchFamily="18" charset="0"/>
              </a:rPr>
              <a:t>.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Tumor sizes were determined in individual mice by measurements of two opposing diameters and are presented as tumor areas in mm</a:t>
            </a:r>
            <a:r>
              <a:rPr lang="en-US" altLang="ko-KR" sz="1050" baseline="30000" dirty="0">
                <a:latin typeface="Cambria" pitchFamily="18" charset="0"/>
                <a:ea typeface="Cambria" pitchFamily="18" charset="0"/>
              </a:rPr>
              <a:t>2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.</a:t>
            </a:r>
            <a:r>
              <a:rPr lang="en-US" altLang="ko-KR" sz="1050" i="1" dirty="0">
                <a:latin typeface="Cambria" panose="02040503050406030204" pitchFamily="18" charset="0"/>
              </a:rPr>
              <a:t>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Points,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mean for each </a:t>
            </a:r>
            <a:r>
              <a:rPr lang="en-US" altLang="ko-KR" sz="1050" dirty="0">
                <a:latin typeface="Cambria" pitchFamily="18" charset="0"/>
              </a:rPr>
              <a:t>group of mice; </a:t>
            </a:r>
            <a:r>
              <a:rPr lang="en-US" altLang="ko-KR" sz="1050" i="1" dirty="0">
                <a:latin typeface="Cambria" pitchFamily="18" charset="0"/>
              </a:rPr>
              <a:t>bars,</a:t>
            </a:r>
            <a:r>
              <a:rPr lang="en-US" altLang="ko-KR" sz="1050" dirty="0">
                <a:latin typeface="Cambria" pitchFamily="18" charset="0"/>
              </a:rPr>
              <a:t> SD. </a:t>
            </a:r>
            <a:r>
              <a:rPr lang="en-US" altLang="ko-KR" sz="1050" b="1" dirty="0">
                <a:latin typeface="Cambria" pitchFamily="18" charset="0"/>
                <a:ea typeface="Cambria" pitchFamily="18" charset="0"/>
              </a:rPr>
              <a:t>A and C.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Tumor growth was monitored by time course of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in vivo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bioluminescence imaging in individual mice (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left panel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, and average radiance per mouse is shown (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right panel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. Images were adjusted to the same pseudo color scale to show relative bioluminescence changes over time. </a:t>
            </a:r>
            <a:r>
              <a:rPr lang="en-US" altLang="ko-KR" sz="1050" i="1" dirty="0">
                <a:latin typeface="Cambria" pitchFamily="18" charset="0"/>
                <a:ea typeface="Cambria" pitchFamily="18" charset="0"/>
              </a:rPr>
              <a:t>Points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average values of photons in mouse; </a:t>
            </a:r>
            <a:r>
              <a:rPr lang="en-US" altLang="ko-KR" sz="1050" i="1" dirty="0">
                <a:latin typeface="Cambria" pitchFamily="18" charset="0"/>
              </a:rPr>
              <a:t>bars,</a:t>
            </a:r>
            <a:r>
              <a:rPr lang="en-US" altLang="ko-KR" sz="1050" dirty="0">
                <a:latin typeface="Cambria" pitchFamily="18" charset="0"/>
              </a:rPr>
              <a:t> SD. 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Non-vaccinated mice (No Vax) and 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-loaded DCs prime-</a:t>
            </a:r>
            <a:r>
              <a:rPr lang="en-US" altLang="ko-KR" sz="1050" dirty="0" err="1">
                <a:latin typeface="Cambria" pitchFamily="18" charset="0"/>
                <a:ea typeface="Cambria" pitchFamily="18" charset="0"/>
              </a:rPr>
              <a:t>TriVax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 booster-vaccinated mice (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 were included as controls. </a:t>
            </a:r>
            <a:r>
              <a:rPr lang="en-US" altLang="ko-KR" sz="1050" dirty="0">
                <a:latin typeface="Cambria" pitchFamily="18" charset="0"/>
              </a:rPr>
              <a:t>These experiments were repeated twice with similar results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DE25B84-FB3E-46E9-98EE-23B818975CF8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3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99444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BFB599D4-DBB9-4409-B702-D555F7DBA7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695" y="839688"/>
            <a:ext cx="2117997" cy="1525396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FA317749-ACB8-415E-A200-2BA469048C1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507" y="6940834"/>
            <a:ext cx="2548772" cy="2330882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76A29D82-3DB6-4042-BF19-0AC4D190CB1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1" t="4809" r="9217" b="3704"/>
          <a:stretch/>
        </p:blipFill>
        <p:spPr>
          <a:xfrm>
            <a:off x="533400" y="2501271"/>
            <a:ext cx="2009483" cy="1489149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E2A25F8-7F04-4B80-A07E-6B3A0EEA3A3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8"/>
          <a:stretch/>
        </p:blipFill>
        <p:spPr>
          <a:xfrm>
            <a:off x="686844" y="4171890"/>
            <a:ext cx="3758329" cy="2588794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835CF7BA-E3B1-4FD1-80A9-CAE6575AF0D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11"/>
          <a:stretch/>
        </p:blipFill>
        <p:spPr>
          <a:xfrm>
            <a:off x="2633237" y="2488028"/>
            <a:ext cx="3758329" cy="1745954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D253A712-EC28-406A-A6A2-97BBE4FD586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374" y="713725"/>
            <a:ext cx="3708734" cy="181128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A1C5178-4095-46F5-96BA-0A114862614B}"/>
              </a:ext>
            </a:extLst>
          </p:cNvPr>
          <p:cNvSpPr txBox="1"/>
          <p:nvPr/>
        </p:nvSpPr>
        <p:spPr>
          <a:xfrm>
            <a:off x="371929" y="68580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E2A64B-CA63-4936-99B0-3334507AF3A5}"/>
              </a:ext>
            </a:extLst>
          </p:cNvPr>
          <p:cNvSpPr txBox="1"/>
          <p:nvPr/>
        </p:nvSpPr>
        <p:spPr>
          <a:xfrm>
            <a:off x="371929" y="23787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EC6787-AFB3-48FC-992F-1524D4970E35}"/>
              </a:ext>
            </a:extLst>
          </p:cNvPr>
          <p:cNvSpPr txBox="1"/>
          <p:nvPr/>
        </p:nvSpPr>
        <p:spPr>
          <a:xfrm>
            <a:off x="2587129" y="6858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45C1F5-3C44-47BA-88AD-9C5A1112AEDE}"/>
              </a:ext>
            </a:extLst>
          </p:cNvPr>
          <p:cNvSpPr txBox="1"/>
          <p:nvPr/>
        </p:nvSpPr>
        <p:spPr>
          <a:xfrm>
            <a:off x="371929" y="408742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422C20-E347-44CF-A853-C04D482E2A84}"/>
              </a:ext>
            </a:extLst>
          </p:cNvPr>
          <p:cNvSpPr txBox="1"/>
          <p:nvPr/>
        </p:nvSpPr>
        <p:spPr>
          <a:xfrm>
            <a:off x="2587129" y="23787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3A599E00-8841-48DD-8CF7-1B0364EE3A1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6019" y="6956899"/>
            <a:ext cx="2514600" cy="231481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B269E4A-F4DF-41FA-9A9F-744D2C426AA2}"/>
              </a:ext>
            </a:extLst>
          </p:cNvPr>
          <p:cNvSpPr txBox="1"/>
          <p:nvPr/>
        </p:nvSpPr>
        <p:spPr>
          <a:xfrm>
            <a:off x="3196987" y="6855306"/>
            <a:ext cx="324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038E44E-C056-4F9F-90B8-3A279A196D82}"/>
              </a:ext>
            </a:extLst>
          </p:cNvPr>
          <p:cNvSpPr txBox="1"/>
          <p:nvPr/>
        </p:nvSpPr>
        <p:spPr>
          <a:xfrm>
            <a:off x="383151" y="685530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6378E7-8DF0-4560-B32C-D84DF5DA88C6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4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62854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03" y="990600"/>
            <a:ext cx="6503034" cy="76962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03496" y="9906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C8B9E75-2150-45B6-924B-E31BB128ABBA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4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1046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F931F7-6055-4078-945A-6357F8A88512}"/>
              </a:ext>
            </a:extLst>
          </p:cNvPr>
          <p:cNvSpPr txBox="1"/>
          <p:nvPr/>
        </p:nvSpPr>
        <p:spPr>
          <a:xfrm>
            <a:off x="228600" y="1828800"/>
            <a:ext cx="6261800" cy="316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i="1" dirty="0">
                <a:latin typeface="Cambria" panose="02040503050406030204" pitchFamily="18" charset="0"/>
              </a:rPr>
              <a:t>Supplementary Figure </a:t>
            </a:r>
            <a:r>
              <a:rPr lang="en-US" altLang="ko-KR" sz="1050" b="1" i="1" dirty="0">
                <a:latin typeface="Cambria" panose="02040503050406030204" pitchFamily="18" charset="0"/>
                <a:ea typeface="Cambria" panose="02040503050406030204" pitchFamily="18" charset="0"/>
              </a:rPr>
              <a:t>S4</a:t>
            </a:r>
            <a:r>
              <a:rPr lang="en-US" altLang="ko-KR" sz="1050" b="1" dirty="0">
                <a:latin typeface="Cambria" pitchFamily="18" charset="0"/>
                <a:ea typeface="Cambria" panose="02040503050406030204" pitchFamily="18" charset="0"/>
              </a:rPr>
              <a:t>. Effects of PD-L1 blockade on the therapeutic efficacy of PLK1</a:t>
            </a:r>
            <a:r>
              <a:rPr lang="en-US" altLang="ko-KR" sz="1050" b="1" baseline="-25000" dirty="0">
                <a:latin typeface="Cambria" pitchFamily="18" charset="0"/>
                <a:ea typeface="Cambria" pitchFamily="18" charset="0"/>
              </a:rPr>
              <a:t>122</a:t>
            </a:r>
            <a:r>
              <a:rPr lang="en-US" altLang="ko-KR" sz="1050" b="1" dirty="0">
                <a:latin typeface="Cambria" pitchFamily="18" charset="0"/>
              </a:rPr>
              <a:t>DC_TriVax</a:t>
            </a:r>
            <a:r>
              <a:rPr lang="en-US" altLang="ko-KR" sz="1050" b="1" dirty="0">
                <a:latin typeface="Cambria" pitchFamily="18" charset="0"/>
                <a:ea typeface="Cambria" panose="02040503050406030204" pitchFamily="18" charset="0"/>
              </a:rPr>
              <a:t> vaccination. 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In a parallel with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Figure 3D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mice (3 per group) were sacrificed on day23, and the tissues and cells from disaggregated tissues were evaluated for the antitumor CD8 T-cell responses and immune cell population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A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Frequency of PLK1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-specific CD8 T-cells in spleen was evaluated by intracellular IFN</a:t>
            </a:r>
            <a:r>
              <a:rPr lang="el-GR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γ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staining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oint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value for each individual mouse;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horizontal line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average of the group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B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Freshly isolated CD8 T-cells from pooled 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splenocyte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were evaluated for antigen-induced IFN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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secretions by 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EliSpot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gainst indicated target cells. Results represent the average number of spots from triplicate wells with SD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bar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of the mean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C-G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Cells from disaggregated tissues of liver, bone-marrow (BM), spleen, and lung were analyzed by flow cytometry for the composition of tumor cells and various subsets of immune cell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C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CD8 T-cell/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Treg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ratio as measured by percentage of CD8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+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T-cells/ percentage of CD4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+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Foxp3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+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T-cell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D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Infiltration of (CD90.1-positive) C1498 leukemic cell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E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Representative flow cytometric plots showing Ly6G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low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Ly6C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high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monocytic myeloid-derived suppressor cells (M-MDSC) and Ly6G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high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Ly6C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low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granulocytic polymorphonuclear MDSC (PMN-MDSC) gated on CD11b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+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CD115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high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myeloid cells in liver tissue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F and G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Quantification of M-MDSC and PMN-MDSC subsets in liver (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F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and lung (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G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tissue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H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Representative images of hematoxylin and eosin (H&amp;E) staining in the tissues with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100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upper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and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1000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lower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magnification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Scale bar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400 </a:t>
            </a:r>
            <a:r>
              <a:rPr lang="el-GR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μ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m in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100 and 40 </a:t>
            </a:r>
            <a:r>
              <a:rPr lang="el-GR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μ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m in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1000. Results represent the average percentage of the gated cells from individual mice with SD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bar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of the means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values were calculated using unpaired Student’s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t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tests (ns, not significant; 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5; 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1; *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01). These experiments were repeated twice with similar results.</a:t>
            </a:r>
            <a:endParaRPr lang="en-US" altLang="ko-KR" sz="1050" b="1" dirty="0">
              <a:latin typeface="Cambria" pitchFamily="18" charset="0"/>
              <a:ea typeface="Cambria" panose="020405030504060302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8BCD74-FA3A-44D0-B80E-5AA194C07649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4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0260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3" t="6189" b="7376"/>
          <a:stretch/>
        </p:blipFill>
        <p:spPr>
          <a:xfrm>
            <a:off x="4344643" y="3653917"/>
            <a:ext cx="1283323" cy="1943979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356" y="3553296"/>
            <a:ext cx="3711244" cy="1936301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204" y="1329267"/>
            <a:ext cx="5928591" cy="2170762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265054" y="129540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1646" y="35000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064000" y="35000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직사각형 26"/>
          <p:cNvSpPr/>
          <p:nvPr/>
        </p:nvSpPr>
        <p:spPr>
          <a:xfrm>
            <a:off x="348523" y="6096000"/>
            <a:ext cx="6097480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i="1" dirty="0">
                <a:latin typeface="Cambria" panose="02040503050406030204" pitchFamily="18" charset="0"/>
              </a:rPr>
              <a:t>Supplementary Figure </a:t>
            </a:r>
            <a:r>
              <a:rPr lang="en-US" altLang="ko-KR" sz="1050" b="1" i="1" dirty="0">
                <a:latin typeface="Cambria" panose="02040503050406030204" pitchFamily="18" charset="0"/>
                <a:ea typeface="Cambria" panose="02040503050406030204" pitchFamily="18" charset="0"/>
              </a:rPr>
              <a:t>S5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. Prolonged period of PD-L1 blockade results in enhanced therapeutic efficacy in PLK1</a:t>
            </a:r>
            <a:r>
              <a:rPr lang="en-US" altLang="ko-KR" sz="1050" b="1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DC_TriVax vaccination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In a parallel with </a:t>
            </a:r>
            <a:r>
              <a:rPr lang="en-US" altLang="ko-KR" sz="1050" i="1" dirty="0">
                <a:latin typeface="Cambria" pitchFamily="18" charset="0"/>
              </a:rPr>
              <a:t>Figure 3D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, anti-PD-L1 and anti-PD-1 were administered three-times (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  <a:sym typeface="Symbol"/>
              </a:rPr>
              <a:t>3)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 on days +1, +3 and +5 for long-term treatment after each immunization in comparison to twice administration of anti-PD-L1 (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  <a:sym typeface="Symbol"/>
              </a:rPr>
              <a:t>2;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on days +1 and +3). Non-vaccinated mice (No Vax) and Ova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55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DC_TriVax-vaccinated mice (Ova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55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were included as controls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A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Tumor growth was monitored by time course of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in vivo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bioluminescence imaging in individual mice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left panel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, and average radiance per mouse is shown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right panel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. Images were adjusted to the same pseudo color scale to show relative bioluminescence changes over time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oint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average values of photons in mouse;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bars,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SD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B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Kaplan-Mayer survival curves for all groups of mice in </a:t>
            </a:r>
            <a:r>
              <a:rPr lang="en-US" altLang="ko-KR" sz="1050" b="1" i="1" dirty="0">
                <a:latin typeface="Cambria" panose="02040503050406030204" pitchFamily="18" charset="0"/>
                <a:ea typeface="Cambria" panose="02040503050406030204" pitchFamily="18" charset="0"/>
              </a:rPr>
              <a:t>A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values were determined by log-rank tests (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1; **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001)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C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t the termination of the experiment (on day74), splenic CD8 T cells from survivor mice were evaluated for antigen-induced IFN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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secretions by 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EliSpot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gainst peptide-pulsed EL4 (EL4/PLK1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, C1498 leukemia, and un-pulsed EL4 cells (negative control). Results represent the average number of spots from triplicate wells with SD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bar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 of the means. These experiments were repeated twice with similar results.</a:t>
            </a:r>
            <a:endParaRPr lang="ko-KR" altLang="ko-KR" sz="1050" dirty="0">
              <a:latin typeface="Cambria" panose="020405030504060302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56387C-B79B-4F69-9C60-D3E55883149C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5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36236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34" y="734170"/>
            <a:ext cx="6199584" cy="3474450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C61AB9CA-F827-4918-B527-7BEA17508271}"/>
              </a:ext>
            </a:extLst>
          </p:cNvPr>
          <p:cNvSpPr/>
          <p:nvPr/>
        </p:nvSpPr>
        <p:spPr>
          <a:xfrm>
            <a:off x="254514" y="6324600"/>
            <a:ext cx="6309319" cy="21929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i="1" dirty="0">
                <a:latin typeface="Cambria" pitchFamily="18" charset="0"/>
              </a:rPr>
              <a:t>Supplementary Figure S6</a:t>
            </a:r>
            <a:r>
              <a:rPr lang="en-US" altLang="ko-KR" sz="1050" b="1" dirty="0">
                <a:latin typeface="Cambria" pitchFamily="18" charset="0"/>
              </a:rPr>
              <a:t>. </a:t>
            </a:r>
            <a:r>
              <a:rPr lang="en-US" altLang="ko-KR" sz="1050" b="1" dirty="0" err="1">
                <a:latin typeface="Cambria" panose="02040503050406030204" pitchFamily="18" charset="0"/>
                <a:ea typeface="Cambria" panose="02040503050406030204" pitchFamily="18" charset="0"/>
              </a:rPr>
              <a:t>DC_TriVax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 vaccination with multi-peptides PLK1</a:t>
            </a:r>
            <a:r>
              <a:rPr lang="en-US" altLang="ko-KR" sz="1050" b="1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 and Sur</a:t>
            </a:r>
            <a:r>
              <a:rPr lang="en-US" altLang="ko-KR" sz="1050" b="1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20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 in combination with sustained PD-L1 blockade elicits augmented therapeutic effectiveness to advanced clonally heterogeneous C1498 myeloid leukemia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B6 mice (5 to 10 per group) were intravenously 2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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10</a:t>
            </a:r>
            <a:r>
              <a:rPr lang="en-US" altLang="ko-KR" sz="1050" baseline="30000" dirty="0">
                <a:latin typeface="Cambria" panose="02040503050406030204" pitchFamily="18" charset="0"/>
                <a:ea typeface="Cambria" panose="02040503050406030204" pitchFamily="18" charset="0"/>
              </a:rPr>
              <a:t>6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C1498-luc cells, and received </a:t>
            </a:r>
            <a:r>
              <a:rPr lang="en-US" altLang="ko-KR" sz="1050" dirty="0" err="1">
                <a:latin typeface="Cambria" panose="02040503050406030204" pitchFamily="18" charset="0"/>
                <a:ea typeface="Cambria" panose="02040503050406030204" pitchFamily="18" charset="0"/>
              </a:rPr>
              <a:t>DC_TriVax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immunization on day14 and 21 using either individual peptide or mixture of PLK1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122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and Sur</a:t>
            </a:r>
            <a:r>
              <a:rPr lang="en-US" altLang="ko-KR" sz="1050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20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(as indicated) with prolonged period of PD-L1 blockade. Non-vaccinated mice (No Vax) and 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DC_TriVax-vaccinated mice (Ova</a:t>
            </a:r>
            <a:r>
              <a:rPr lang="en-US" altLang="ko-KR" sz="1050" baseline="-25000" dirty="0">
                <a:latin typeface="Cambria" pitchFamily="18" charset="0"/>
                <a:ea typeface="Cambria" pitchFamily="18" charset="0"/>
              </a:rPr>
              <a:t>55</a:t>
            </a:r>
            <a:r>
              <a:rPr lang="en-US" altLang="ko-KR" sz="1050" dirty="0">
                <a:latin typeface="Cambria" pitchFamily="18" charset="0"/>
                <a:ea typeface="Cambria" pitchFamily="18" charset="0"/>
              </a:rPr>
              <a:t>) were included as controls. Anti-PD-L1 was administered three-times (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  <a:sym typeface="Symbol"/>
              </a:rPr>
              <a:t>3)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 on days +1, +3 and +5 for long-term treatment after each immunization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A. 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Tumor growth was monitored by time course of </a:t>
            </a:r>
            <a:r>
              <a:rPr lang="en-US" altLang="ko-KR" sz="1050" i="1" dirty="0">
                <a:latin typeface="Cambria" pitchFamily="18" charset="0"/>
                <a:ea typeface="Cambria" panose="02040503050406030204" pitchFamily="18" charset="0"/>
              </a:rPr>
              <a:t>in vivo</a:t>
            </a:r>
            <a:r>
              <a:rPr lang="en-US" altLang="ko-KR" sz="1050" dirty="0">
                <a:latin typeface="Cambria" pitchFamily="18" charset="0"/>
                <a:ea typeface="Cambria" panose="02040503050406030204" pitchFamily="18" charset="0"/>
              </a:rPr>
              <a:t> bioluminescence imaging in individual mice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left panel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, and average radiance per mouse is shown (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right panel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). Images were adjusted to the same pseudo color scale to show relative bioluminescence changes over time.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oint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average values of photons in mouse;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bars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, SD. </a:t>
            </a:r>
            <a:r>
              <a:rPr lang="en-US" altLang="ko-KR" sz="1050" b="1" dirty="0">
                <a:latin typeface="Cambria" panose="02040503050406030204" pitchFamily="18" charset="0"/>
                <a:ea typeface="Cambria" panose="02040503050406030204" pitchFamily="18" charset="0"/>
              </a:rPr>
              <a:t>B.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Kaplan-Mayer survival curves for all groups of mice in </a:t>
            </a:r>
            <a:r>
              <a:rPr lang="en-US" altLang="ko-KR" sz="1050" b="1" i="1" dirty="0">
                <a:latin typeface="Cambria" panose="02040503050406030204" pitchFamily="18" charset="0"/>
                <a:ea typeface="Cambria" panose="02040503050406030204" pitchFamily="18" charset="0"/>
              </a:rPr>
              <a:t>A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.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values were determined by log-rank tests (</a:t>
            </a:r>
            <a:r>
              <a:rPr lang="en-US" altLang="ko-KR" sz="1050" dirty="0">
                <a:latin typeface="Cambria" pitchFamily="18" charset="0"/>
              </a:rPr>
              <a:t>ns, not significant; 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1;  *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01; ****, </a:t>
            </a:r>
            <a:r>
              <a:rPr lang="en-US" altLang="ko-KR" sz="1050" i="1" dirty="0">
                <a:latin typeface="Cambria" panose="02040503050406030204" pitchFamily="18" charset="0"/>
                <a:ea typeface="Cambria" panose="02040503050406030204" pitchFamily="18" charset="0"/>
              </a:rPr>
              <a:t>P</a:t>
            </a:r>
            <a:r>
              <a:rPr lang="en-US" altLang="ko-KR" sz="1050" dirty="0">
                <a:latin typeface="Cambria" panose="02040503050406030204" pitchFamily="18" charset="0"/>
                <a:ea typeface="Cambria" panose="02040503050406030204" pitchFamily="18" charset="0"/>
              </a:rPr>
              <a:t> &lt;0.0001). These experiments were repeated twice with similar results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921" y="4145041"/>
            <a:ext cx="3962400" cy="197516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4386" y="65101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4386" y="408256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51BB91-C4C5-402C-9273-59E7ABFD1A2F}"/>
              </a:ext>
            </a:extLst>
          </p:cNvPr>
          <p:cNvSpPr txBox="1"/>
          <p:nvPr/>
        </p:nvSpPr>
        <p:spPr>
          <a:xfrm>
            <a:off x="3820247" y="9525000"/>
            <a:ext cx="28632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Figure S6; Shin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TH-2020-4070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759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86</TotalTime>
  <Words>1989</Words>
  <Application>Microsoft Office PowerPoint</Application>
  <PresentationFormat>A4 용지(210x297mm)</PresentationFormat>
  <Paragraphs>196</Paragraphs>
  <Slides>9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3" baseType="lpstr">
      <vt:lpstr>맑은 고딕</vt:lpstr>
      <vt:lpstr>Arial</vt:lpstr>
      <vt:lpstr>Cambria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un Cho</dc:creator>
  <cp:lastModifiedBy>SAMSUNG</cp:lastModifiedBy>
  <cp:revision>739</cp:revision>
  <cp:lastPrinted>2019-11-13T03:13:19Z</cp:lastPrinted>
  <dcterms:created xsi:type="dcterms:W3CDTF">2018-12-11T23:29:22Z</dcterms:created>
  <dcterms:modified xsi:type="dcterms:W3CDTF">2020-05-28T06:46:00Z</dcterms:modified>
</cp:coreProperties>
</file>